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4"/>
  </p:notesMasterIdLst>
  <p:sldIdLst>
    <p:sldId id="429" r:id="rId2"/>
    <p:sldId id="430" r:id="rId3"/>
  </p:sldIdLst>
  <p:sldSz cx="6858000" cy="9144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4552" autoAdjust="0"/>
    <p:restoredTop sz="82357" autoAdjust="0"/>
  </p:normalViewPr>
  <p:slideViewPr>
    <p:cSldViewPr>
      <p:cViewPr varScale="1">
        <p:scale>
          <a:sx n="60" d="100"/>
          <a:sy n="60" d="100"/>
        </p:scale>
        <p:origin x="291" y="4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-576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E52B42-2097-4F88-8CCC-416F07181C37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DAEFAB-0484-4E6B-9F13-F40C036162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38784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AB2BD-AE83-449E-AEF2-D03DED9554CC}" type="datetimeFigureOut">
              <a:rPr lang="ko-KR" altLang="en-US" smtClean="0"/>
              <a:pPr/>
              <a:t>2022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jpeg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내용 개체 틀 2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 flipH="1">
            <a:off x="574731" y="1248853"/>
            <a:ext cx="3216366" cy="4100239"/>
          </a:xfrm>
        </p:spPr>
      </p:pic>
      <p:graphicFrame>
        <p:nvGraphicFramePr>
          <p:cNvPr id="6" name="개체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3430239"/>
              </p:ext>
            </p:extLst>
          </p:nvPr>
        </p:nvGraphicFramePr>
        <p:xfrm>
          <a:off x="620687" y="6876256"/>
          <a:ext cx="4254500" cy="1816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3132" name="Image" r:id="rId4" imgW="4253760" imgH="1815840" progId="Photoshop.Image.7">
                  <p:embed/>
                </p:oleObj>
              </mc:Choice>
              <mc:Fallback>
                <p:oleObj name="Image" r:id="rId4" imgW="4253760" imgH="1815840" progId="Photoshop.Image.7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0687" y="6876256"/>
                        <a:ext cx="4254500" cy="1816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그림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4005064" y="1248852"/>
            <a:ext cx="2520280" cy="4132985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1628800" y="2627784"/>
            <a:ext cx="720080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/>
          <p:cNvSpPr/>
          <p:nvPr/>
        </p:nvSpPr>
        <p:spPr>
          <a:xfrm>
            <a:off x="4905164" y="2746353"/>
            <a:ext cx="720080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1700808" y="7059597"/>
            <a:ext cx="446534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TextBox 9"/>
          <p:cNvSpPr txBox="1"/>
          <p:nvPr/>
        </p:nvSpPr>
        <p:spPr>
          <a:xfrm rot="16200000">
            <a:off x="1426176" y="1857840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직사각형 12"/>
          <p:cNvSpPr/>
          <p:nvPr/>
        </p:nvSpPr>
        <p:spPr>
          <a:xfrm rot="16200000">
            <a:off x="1760578" y="1712691"/>
            <a:ext cx="8996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KOV3-SP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직사각형 20"/>
          <p:cNvSpPr/>
          <p:nvPr/>
        </p:nvSpPr>
        <p:spPr>
          <a:xfrm rot="15980071">
            <a:off x="4779936" y="1993730"/>
            <a:ext cx="6783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직사각형 21"/>
          <p:cNvSpPr/>
          <p:nvPr/>
        </p:nvSpPr>
        <p:spPr>
          <a:xfrm rot="16200000">
            <a:off x="5067962" y="1923862"/>
            <a:ext cx="8996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-SP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직사각형 22"/>
          <p:cNvSpPr/>
          <p:nvPr/>
        </p:nvSpPr>
        <p:spPr>
          <a:xfrm rot="16200000">
            <a:off x="1559039" y="6258162"/>
            <a:ext cx="8996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-SP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직사각형 23"/>
          <p:cNvSpPr/>
          <p:nvPr/>
        </p:nvSpPr>
        <p:spPr>
          <a:xfrm rot="16200000">
            <a:off x="1392970" y="6365196"/>
            <a:ext cx="6783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664836" y="1196717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K3R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flipH="1">
            <a:off x="4875187" y="1283218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293902" y="568549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CT4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1124744" y="7164288"/>
            <a:ext cx="360041" cy="3273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/>
          <p:cNvSpPr/>
          <p:nvPr/>
        </p:nvSpPr>
        <p:spPr>
          <a:xfrm rot="16200000">
            <a:off x="1006158" y="6323463"/>
            <a:ext cx="8242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2780-SP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직사각형 18"/>
          <p:cNvSpPr/>
          <p:nvPr/>
        </p:nvSpPr>
        <p:spPr>
          <a:xfrm rot="16200000">
            <a:off x="840091" y="6430497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278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1330" y="316762"/>
            <a:ext cx="577831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- </a:t>
            </a:r>
            <a:r>
              <a:rPr lang="en-US" altLang="ko-KR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cropped Western blots presented in the current study.</a:t>
            </a:r>
          </a:p>
          <a:p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1003116" y="5963577"/>
            <a:ext cx="11797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>
            <a:off x="1736812" y="1467617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/>
          <p:cNvCxnSpPr/>
          <p:nvPr/>
        </p:nvCxnSpPr>
        <p:spPr>
          <a:xfrm>
            <a:off x="4966021" y="1642071"/>
            <a:ext cx="6120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1738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1547733"/>
            <a:ext cx="6110436" cy="3807332"/>
          </a:xfrm>
        </p:spPr>
      </p:pic>
      <p:sp>
        <p:nvSpPr>
          <p:cNvPr id="6" name="직사각형 5"/>
          <p:cNvSpPr/>
          <p:nvPr/>
        </p:nvSpPr>
        <p:spPr>
          <a:xfrm>
            <a:off x="2400155" y="2903800"/>
            <a:ext cx="504056" cy="2880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 rot="16200000">
            <a:off x="2229904" y="2201162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78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2960949" y="7236296"/>
            <a:ext cx="504056" cy="2880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609" y="5220072"/>
            <a:ext cx="5112568" cy="3581164"/>
          </a:xfrm>
          <a:prstGeom prst="rect">
            <a:avLst/>
          </a:prstGeom>
        </p:spPr>
      </p:pic>
      <p:sp>
        <p:nvSpPr>
          <p:cNvPr id="12" name="직사각형 11"/>
          <p:cNvSpPr/>
          <p:nvPr/>
        </p:nvSpPr>
        <p:spPr>
          <a:xfrm>
            <a:off x="2210171" y="6650614"/>
            <a:ext cx="498750" cy="28803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/>
          <p:cNvSpPr/>
          <p:nvPr/>
        </p:nvSpPr>
        <p:spPr>
          <a:xfrm rot="16200000">
            <a:off x="2353579" y="2111405"/>
            <a:ext cx="8242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2780-SP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직사각형 13"/>
          <p:cNvSpPr/>
          <p:nvPr/>
        </p:nvSpPr>
        <p:spPr>
          <a:xfrm rot="16200000">
            <a:off x="1984897" y="5855621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78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350212" y="1572869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K3R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2076580" y="5755031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2780-SP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036902" y="5309997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6672" y="294571"/>
            <a:ext cx="525658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-</a:t>
            </a:r>
            <a:r>
              <a:rPr lang="en-US" altLang="ko-KR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cropped Western blots presented in the current study.</a:t>
            </a:r>
          </a:p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2492896" y="1837771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/>
          <p:cNvCxnSpPr/>
          <p:nvPr/>
        </p:nvCxnSpPr>
        <p:spPr>
          <a:xfrm>
            <a:off x="2143588" y="5580112"/>
            <a:ext cx="5220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62805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88</TotalTime>
  <Words>39</Words>
  <Application>Microsoft Office PowerPoint</Application>
  <PresentationFormat>화면 슬라이드 쇼(4:3)</PresentationFormat>
  <Paragraphs>20</Paragraphs>
  <Slides>2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Image</vt:lpstr>
      <vt:lpstr>PowerPoint 프레젠테이션</vt:lpstr>
      <vt:lpstr>PowerPoint 프레젠테이션</vt:lpstr>
    </vt:vector>
  </TitlesOfParts>
  <Company>XP SP3 FIN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Beom</dc:creator>
  <cp:lastModifiedBy>admin</cp:lastModifiedBy>
  <cp:revision>3059</cp:revision>
  <cp:lastPrinted>2021-02-22T01:39:59Z</cp:lastPrinted>
  <dcterms:created xsi:type="dcterms:W3CDTF">2012-07-26T06:55:51Z</dcterms:created>
  <dcterms:modified xsi:type="dcterms:W3CDTF">2022-06-15T02:01:49Z</dcterms:modified>
</cp:coreProperties>
</file>